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13214A-B6A9-4FDC-A93D-1FC4872B26F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43A00E-3119-4774-BC4C-AE270DFBF8A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3BFEBC-1CD2-420D-9788-F68F8BF6E07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125CA2-D1EA-4AD8-ABC2-E5CDF1BCF3E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DD7110-EBA0-49F1-B3A0-0F9C393792A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F006D0-BDAB-4382-BB2F-9AEB1AB1E17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908E48-1A95-46D4-8825-A83D39B3A93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ED57E0-8FF0-4E3A-A12F-79FBF027466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3B0EF3-BDDA-4251-A41E-786ADAF5E2D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430A63-EADE-49B8-99F2-3DA4CEECE78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A92ABC-D5A7-48C0-8DD1-2F2FE85A32E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63738A-118E-4051-BF1E-324C3806714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CH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02E8F76-682E-45DE-B882-793511FB0532}" type="slidenum">
              <a:rPr b="0" lang="de-CH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subTitle"/>
          </p:nvPr>
        </p:nvSpPr>
        <p:spPr>
          <a:xfrm>
            <a:off x="3779640" y="549360"/>
            <a:ext cx="1655640" cy="5047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anchor="t">
            <a:noAutofit/>
          </a:bodyPr>
          <a:p>
            <a:pPr algn="ctr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ssessed for eligibility (n=22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Line 4"/>
          <p:cNvSpPr/>
          <p:nvPr/>
        </p:nvSpPr>
        <p:spPr>
          <a:xfrm>
            <a:off x="4572000" y="1197000"/>
            <a:ext cx="0" cy="2872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5"/>
          <p:cNvSpPr/>
          <p:nvPr/>
        </p:nvSpPr>
        <p:spPr>
          <a:xfrm>
            <a:off x="3895560" y="1700280"/>
            <a:ext cx="1368720" cy="2887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ctr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rescreenin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6"/>
          <p:cNvSpPr/>
          <p:nvPr/>
        </p:nvSpPr>
        <p:spPr>
          <a:xfrm>
            <a:off x="6145200" y="1446120"/>
            <a:ext cx="1873440" cy="7923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Excluded (n=6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3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efused to participat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3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edical reas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Line 7"/>
          <p:cNvSpPr/>
          <p:nvPr/>
        </p:nvSpPr>
        <p:spPr>
          <a:xfrm flipV="1">
            <a:off x="5435640" y="1844280"/>
            <a:ext cx="288720" cy="18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Line 8"/>
          <p:cNvSpPr/>
          <p:nvPr/>
        </p:nvSpPr>
        <p:spPr>
          <a:xfrm>
            <a:off x="4572000" y="2133720"/>
            <a:ext cx="0" cy="2872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tangle 9"/>
          <p:cNvSpPr/>
          <p:nvPr/>
        </p:nvSpPr>
        <p:spPr>
          <a:xfrm>
            <a:off x="3348000" y="2563920"/>
            <a:ext cx="2736720" cy="649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ctr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andomized (n=16) assignment of order of all 4 drug condition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tangle 10"/>
          <p:cNvSpPr/>
          <p:nvPr/>
        </p:nvSpPr>
        <p:spPr>
          <a:xfrm>
            <a:off x="324000" y="3645000"/>
            <a:ext cx="1726920" cy="5047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ctr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lacebo-Placebo (n=16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11"/>
          <p:cNvSpPr/>
          <p:nvPr/>
        </p:nvSpPr>
        <p:spPr>
          <a:xfrm>
            <a:off x="2556000" y="3645000"/>
            <a:ext cx="1822320" cy="5047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ctr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lacebo-MDM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(n=16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12"/>
          <p:cNvSpPr/>
          <p:nvPr/>
        </p:nvSpPr>
        <p:spPr>
          <a:xfrm>
            <a:off x="4859280" y="3645000"/>
            <a:ext cx="1728720" cy="5047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ctr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upropion-Placeb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(n=16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13"/>
          <p:cNvSpPr/>
          <p:nvPr/>
        </p:nvSpPr>
        <p:spPr>
          <a:xfrm>
            <a:off x="7020000" y="3645000"/>
            <a:ext cx="1800000" cy="5047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ctr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upropion-MDM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(n=16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Line 14"/>
          <p:cNvSpPr/>
          <p:nvPr/>
        </p:nvSpPr>
        <p:spPr>
          <a:xfrm>
            <a:off x="3492360" y="3284640"/>
            <a:ext cx="0" cy="2872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Line 15"/>
          <p:cNvSpPr/>
          <p:nvPr/>
        </p:nvSpPr>
        <p:spPr>
          <a:xfrm>
            <a:off x="5724360" y="3284640"/>
            <a:ext cx="0" cy="2872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Line 16"/>
          <p:cNvSpPr/>
          <p:nvPr/>
        </p:nvSpPr>
        <p:spPr>
          <a:xfrm>
            <a:off x="7885080" y="3286080"/>
            <a:ext cx="0" cy="2872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Line 17"/>
          <p:cNvSpPr/>
          <p:nvPr/>
        </p:nvSpPr>
        <p:spPr>
          <a:xfrm>
            <a:off x="1116000" y="3284640"/>
            <a:ext cx="0" cy="2872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Line 18"/>
          <p:cNvSpPr/>
          <p:nvPr/>
        </p:nvSpPr>
        <p:spPr>
          <a:xfrm>
            <a:off x="1116000" y="3213000"/>
            <a:ext cx="6769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20"/>
          <p:cNvSpPr/>
          <p:nvPr/>
        </p:nvSpPr>
        <p:spPr>
          <a:xfrm>
            <a:off x="2627280" y="4724280"/>
            <a:ext cx="3960720" cy="289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ctr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ll participants completed the study (n=16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21"/>
          <p:cNvSpPr/>
          <p:nvPr/>
        </p:nvSpPr>
        <p:spPr>
          <a:xfrm>
            <a:off x="7380360" y="4724280"/>
            <a:ext cx="1368360" cy="289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ctr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rop outs (n=0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22"/>
          <p:cNvSpPr/>
          <p:nvPr/>
        </p:nvSpPr>
        <p:spPr>
          <a:xfrm flipV="1">
            <a:off x="6804000" y="4866840"/>
            <a:ext cx="289080" cy="18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23"/>
          <p:cNvSpPr/>
          <p:nvPr/>
        </p:nvSpPr>
        <p:spPr>
          <a:xfrm>
            <a:off x="2649600" y="5732640"/>
            <a:ext cx="3960720" cy="2887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ctr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ata analyzed (n=16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Line 24"/>
          <p:cNvSpPr/>
          <p:nvPr/>
        </p:nvSpPr>
        <p:spPr>
          <a:xfrm>
            <a:off x="4627440" y="4294080"/>
            <a:ext cx="0" cy="2872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25"/>
          <p:cNvSpPr/>
          <p:nvPr/>
        </p:nvSpPr>
        <p:spPr>
          <a:xfrm>
            <a:off x="4643280" y="5084640"/>
            <a:ext cx="0" cy="2876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9-12T13:11:47Z</dcterms:created>
  <dc:creator>LiechtiM</dc:creator>
  <dc:description/>
  <dc:language>en-US</dc:language>
  <cp:lastModifiedBy>Liechti Matthias</cp:lastModifiedBy>
  <dcterms:modified xsi:type="dcterms:W3CDTF">2015-11-19T10:33:53Z</dcterms:modified>
  <cp:revision>4</cp:revision>
  <dc:subject/>
  <dc:title>Folie 1</dc:title>
</cp:coreProperties>
</file>